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762120" y="1736640"/>
            <a:ext cx="1752480" cy="703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nput Populatio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"/>
          <p:cNvSpPr/>
          <p:nvPr/>
        </p:nvSpPr>
        <p:spPr>
          <a:xfrm>
            <a:off x="2590920" y="2041560"/>
            <a:ext cx="99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"/>
          <p:cNvSpPr/>
          <p:nvPr/>
        </p:nvSpPr>
        <p:spPr>
          <a:xfrm>
            <a:off x="3657600" y="1432080"/>
            <a:ext cx="1752480" cy="12333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ode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1"/>
          <p:cNvSpPr>
            <a:spLocks noGrp="1"/>
          </p:cNvSpPr>
          <p:nvPr>
            <p:ph/>
          </p:nvPr>
        </p:nvSpPr>
        <p:spPr>
          <a:xfrm>
            <a:off x="6629400" y="1736280"/>
            <a:ext cx="1752480" cy="685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txBody>
          <a:bodyPr anchor="t">
            <a:normAutofit/>
          </a:bodyPr>
          <a:p>
            <a:pPr marL="343080" indent="0" algn="ctr">
              <a:spcBef>
                <a:spcPts val="12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Outputs</a:t>
            </a:r>
            <a:endParaRPr b="0" lang="en-US" sz="20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486400" y="204156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09480" y="2743200"/>
            <a:ext cx="2514600" cy="346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Population of 183,826 people in Matla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ndividual attributes: age, sex, GIS location of bar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eded with five randomly chosen unvaccinated initial infectiv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52680" y="2743200"/>
            <a:ext cx="2819520" cy="22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NSI c code models cholera natural history, transmission dynamics (based on an infection probability function) and mass vaccination strategi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400800" y="2743200"/>
            <a:ext cx="2743200" cy="346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llness attack rates in unvaccinated and vaccinated groups, and effectiveness measur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ndividual level outcomes produce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patial distribution of cholera cases recorde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V="1">
            <a:off x="272880" y="57384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rot="10800000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2:53:31Z</dcterms:modified>
  <cp:revision>297</cp:revision>
  <dc:subject/>
  <dc:title>Slide 1</dc:title>
</cp:coreProperties>
</file>